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158B09-125D-4525-8E40-61066E59BB1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FAA839-E672-4F84-B4D8-4999F90029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72587E-5FBC-4735-A9DE-C588D278405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0C24F1-8A3F-42EB-8059-05D82F1D281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DD3C8C-1090-4DFD-AA26-0C49134D674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77D3C5-6A8A-430E-85E4-9F406DECA81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27ECE7-EEB9-4988-BF74-C3FBBFC414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0D2BDF-4816-48E1-AFD8-69FBAE6F939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0EE109-A467-4154-B703-574B4806AB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0AC244-369C-4A7D-AB86-7C14159D7C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3C32D8-60CF-4D30-B39D-0458112F41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EAA8D0-4CC8-44F4-BF24-A2A941B4ED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19800"/>
            <a:ext cx="160020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19800"/>
            <a:ext cx="217152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19800"/>
            <a:ext cx="160020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7B82D8E-6C3D-4535-9AF0-9FB4BA858CB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985680" y="3276720"/>
            <a:ext cx="4734000" cy="294480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2044080" y="6184800"/>
            <a:ext cx="2728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Mutual Information (Normalized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190600" y="5902200"/>
            <a:ext cx="3738600" cy="128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255840" y="3341520"/>
            <a:ext cx="362160" cy="128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rot="16200000">
            <a:off x="806400" y="4641840"/>
            <a:ext cx="2719440" cy="128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rot="16200000">
            <a:off x="579960" y="4561200"/>
            <a:ext cx="2423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Correlation coeficient (Corr.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931040" y="336708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931040" y="384660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931040" y="433548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931040" y="481968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931040" y="530388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931040" y="578808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127600" y="59482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556360" y="594828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3042360" y="594828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3528000" y="594828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023360" y="594828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4513680" y="594828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722760" y="3502080"/>
            <a:ext cx="895320" cy="871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0" name=""/>
          <p:cNvGrpSpPr/>
          <p:nvPr/>
        </p:nvGrpSpPr>
        <p:grpSpPr>
          <a:xfrm>
            <a:off x="3785040" y="3642120"/>
            <a:ext cx="20520" cy="20520"/>
            <a:chOff x="3785040" y="3642120"/>
            <a:chExt cx="20520" cy="20520"/>
          </a:xfrm>
        </p:grpSpPr>
        <p:sp>
          <p:nvSpPr>
            <p:cNvPr id="61" name=""/>
            <p:cNvSpPr/>
            <p:nvPr/>
          </p:nvSpPr>
          <p:spPr>
            <a:xfrm>
              <a:off x="3785040" y="3643200"/>
              <a:ext cx="20520" cy="1944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360" bIns="-27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 flipV="1">
              <a:off x="3785760" y="3642120"/>
              <a:ext cx="19800" cy="2052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3" name=""/>
          <p:cNvSpPr/>
          <p:nvPr/>
        </p:nvSpPr>
        <p:spPr>
          <a:xfrm>
            <a:off x="3773880" y="3564000"/>
            <a:ext cx="605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Arial"/>
              </a:rPr>
              <a:t>Not selected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4" name=""/>
          <p:cNvGrpSpPr/>
          <p:nvPr/>
        </p:nvGrpSpPr>
        <p:grpSpPr>
          <a:xfrm>
            <a:off x="3785040" y="3858120"/>
            <a:ext cx="20520" cy="20520"/>
            <a:chOff x="3785040" y="3858120"/>
            <a:chExt cx="20520" cy="20520"/>
          </a:xfrm>
        </p:grpSpPr>
        <p:sp>
          <p:nvSpPr>
            <p:cNvPr id="65" name=""/>
            <p:cNvSpPr/>
            <p:nvPr/>
          </p:nvSpPr>
          <p:spPr>
            <a:xfrm>
              <a:off x="3785040" y="3859200"/>
              <a:ext cx="20520" cy="19440"/>
            </a:xfrm>
            <a:prstGeom prst="line">
              <a:avLst/>
            </a:prstGeom>
            <a:ln w="6480">
              <a:solidFill>
                <a:srgbClr val="66ff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360" bIns="-27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 flipV="1">
              <a:off x="3785760" y="3858120"/>
              <a:ext cx="19800" cy="20520"/>
            </a:xfrm>
            <a:prstGeom prst="line">
              <a:avLst/>
            </a:prstGeom>
            <a:ln w="6480">
              <a:solidFill>
                <a:srgbClr val="66ff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7" name=""/>
          <p:cNvGrpSpPr/>
          <p:nvPr/>
        </p:nvGrpSpPr>
        <p:grpSpPr>
          <a:xfrm>
            <a:off x="3785040" y="4074120"/>
            <a:ext cx="20520" cy="20520"/>
            <a:chOff x="3785040" y="4074120"/>
            <a:chExt cx="20520" cy="20520"/>
          </a:xfrm>
        </p:grpSpPr>
        <p:sp>
          <p:nvSpPr>
            <p:cNvPr id="68" name=""/>
            <p:cNvSpPr/>
            <p:nvPr/>
          </p:nvSpPr>
          <p:spPr>
            <a:xfrm>
              <a:off x="3785040" y="4075200"/>
              <a:ext cx="20520" cy="19440"/>
            </a:xfrm>
            <a:prstGeom prst="line">
              <a:avLst/>
            </a:prstGeom>
            <a:ln w="64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360" bIns="-27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 flipV="1">
              <a:off x="3785760" y="4074120"/>
              <a:ext cx="19800" cy="20520"/>
            </a:xfrm>
            <a:prstGeom prst="line">
              <a:avLst/>
            </a:prstGeom>
            <a:ln w="64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0" name=""/>
          <p:cNvGrpSpPr/>
          <p:nvPr/>
        </p:nvGrpSpPr>
        <p:grpSpPr>
          <a:xfrm>
            <a:off x="3785400" y="4289760"/>
            <a:ext cx="20520" cy="20880"/>
            <a:chOff x="3785400" y="4289760"/>
            <a:chExt cx="20520" cy="20880"/>
          </a:xfrm>
        </p:grpSpPr>
        <p:sp>
          <p:nvSpPr>
            <p:cNvPr id="71" name=""/>
            <p:cNvSpPr/>
            <p:nvPr/>
          </p:nvSpPr>
          <p:spPr>
            <a:xfrm>
              <a:off x="3785400" y="4290840"/>
              <a:ext cx="20520" cy="19800"/>
            </a:xfrm>
            <a:prstGeom prst="line">
              <a:avLst/>
            </a:prstGeom>
            <a:ln w="6480">
              <a:solidFill>
                <a:srgbClr val="3333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000" bIns="-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 flipV="1">
              <a:off x="3786120" y="4289760"/>
              <a:ext cx="19440" cy="20520"/>
            </a:xfrm>
            <a:prstGeom prst="line">
              <a:avLst/>
            </a:prstGeom>
            <a:ln w="6480">
              <a:solidFill>
                <a:srgbClr val="3333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3" name=""/>
          <p:cNvSpPr/>
          <p:nvPr/>
        </p:nvSpPr>
        <p:spPr>
          <a:xfrm>
            <a:off x="3773160" y="3780000"/>
            <a:ext cx="6865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Arial"/>
              </a:rPr>
              <a:t>Selected by MI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3772080" y="3995640"/>
            <a:ext cx="900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Arial"/>
              </a:rPr>
              <a:t>Selected by FDR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3773520" y="4210200"/>
            <a:ext cx="750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Arial"/>
              </a:rPr>
              <a:t>Selected by both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568440" y="7991640"/>
            <a:ext cx="586584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igure S1: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Selection of the mutual information values.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The graph plotted the mutual information versus the absolute value of the correlation coefficient. The green dots correspond to the 266 probesets selected based on their mutual information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62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1-10T20:29:58Z</dcterms:created>
  <dc:creator>Marie-Noëlle Delyfer</dc:creator>
  <dc:description/>
  <dc:language>en-US</dc:language>
  <cp:lastModifiedBy>U592</cp:lastModifiedBy>
  <dcterms:modified xsi:type="dcterms:W3CDTF">2011-11-16T07:44:52Z</dcterms:modified>
  <cp:revision>150</cp:revision>
  <dc:subject/>
  <dc:title>Diapositive 1</dc:title>
</cp:coreProperties>
</file>